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1" r:id="rId5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8CB9211-00A8-1A46-DC1F-06435F512D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8E01D8E-6F39-D475-CF01-58FC1C55A6C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959E47C-6870-0F1F-4F61-5BE62559DC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E5200D6-835D-09FD-4DC0-712659F36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EACD64-4CC7-9A3D-4A1B-2AE6082DC5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7598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9A20513-8987-58BC-9B4C-9F0380A97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56C2BE0-3ABF-E730-3251-099FA2A703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05E8E1-598E-F570-B627-2138CE5479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24579C-DC37-7DD6-AEB4-6B8E7AC40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7E9821-C48C-3E5F-A183-D5415DCBA9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80358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A26450C-B64F-2061-E3F9-23DC6B83BE5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A31E174-6AB8-4723-286E-69061DAF2C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03A37F-1255-2531-09F3-6B4CE792F5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4F86838-5D54-CE7C-8A17-DE9708720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B5C77C-0D3E-711E-016E-C9C9C11A8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50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6F89379-91E4-A322-7D3B-887214573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CC9C7662-FEE5-8A04-195C-DAC1672EA98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8DE598D-72CC-AD5F-DE00-9B84364E3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AC0585-304F-455F-F95D-65B3376DB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8746782-77E8-B93D-8533-7847881C86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6673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6DE817-4F3B-98B8-9EA8-FC9A5ABF7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AA937F3-422D-E775-6B26-653FA2F23A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7FD283C-8F86-01B8-B400-18BB4DF4F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3A63C28-6FBC-4BC0-A175-D66D00DDD9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3A4B945-EA9D-45B2-CC10-14536121BA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8651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D9814A3-712E-D548-4703-A773B1E5F0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839CF4D-5839-C861-B9A1-2712E0188F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DD46C7B-B554-3BFC-89E9-A060B18CDC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0FAC444-7314-97D8-7512-A4286984D2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6598F23-6462-D891-C98B-E24A5927D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5DE6E12-FED6-D876-0F2F-728F175BCE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44089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873DBA6-1E19-DF1D-B966-75FC83E90F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F10C0D5-BF71-AE1F-1553-18C6FAE276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C821397-0F21-01AD-D31E-02187A6A2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147813DF-FD74-D065-328B-59E9A2316A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F1D0E79-C3C7-5CAF-AE85-F1D8F80AE4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57A6B40-4564-2F3E-5496-EA76A8BB51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592D5B9-1C04-1902-19F9-A8C9650E7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2C4BCBB8-9D75-A820-4A95-660E4B733D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662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3ED6E5-F7A0-590B-4763-FEC3EB9059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A5E2D41E-F369-2842-028B-DAD333B004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B9A918F-8293-A3B7-0EE6-04CA99C01E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579CF2-3CF7-16C7-92EA-B4F97ABA9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0005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384D7FA-9FD6-32BB-6594-7E5891760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C881398B-1682-28E7-1C58-30F270F99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1A4A060-8198-AD09-988F-FE5E2D170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0980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AE57B2-591F-7A10-9E2D-FC38AA58E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E99D129-7524-8A59-2B56-5115F1F739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C516E52-3E94-4B68-43AE-50533EFF57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012942-A354-F3B8-51DC-9E440EE8AD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37895A-CBE7-9762-5FD0-5960B74BE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F58F9C1-EDAF-63EF-6262-12585D9604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7351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2528D69-1D37-B3D7-5AEE-8D6892EC0D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54665C8-7C85-00E6-0E24-A04EA121A7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26FAFC2-7714-6967-269E-B7220A51998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91EC350-DDC1-FE3B-60AD-2A50DD1E2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8A24A9C-3ED4-66CB-A46E-FC0750458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B754CB3-CDD6-9885-D17C-EE87B29D42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5292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AEA49AA3-3357-9580-5907-98AEF8A1FE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20F02E4-ED50-B9FD-C26B-E6248D438E1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DE21454-0B90-4BAC-2FEF-F481E3C2B42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1CEEA-735C-4DAB-AE4B-12608D39134E}" type="datetimeFigureOut">
              <a:rPr kumimoji="1" lang="ja-JP" altLang="en-US" smtClean="0"/>
              <a:t>2023/8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10EB3A3-B905-05DC-2E8E-0EBCC87D0A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23C09B1-2FB1-BD91-CA92-AB3315FCBC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AFD20C-8121-4576-BDD8-09FF310721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0084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 descr="滝の写真&#10;&#10;低い精度で自動的に生成された説明">
            <a:extLst>
              <a:ext uri="{FF2B5EF4-FFF2-40B4-BE49-F238E27FC236}">
                <a16:creationId xmlns:a16="http://schemas.microsoft.com/office/drawing/2014/main" id="{66BC12F5-B52A-6B2D-D7B4-86E62F934A7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" t="15190" r="24984" b="6793"/>
          <a:stretch/>
        </p:blipFill>
        <p:spPr>
          <a:xfrm rot="5400000">
            <a:off x="2810673" y="895281"/>
            <a:ext cx="5253492" cy="410901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14BFF73F-8AEC-FDFE-2333-4B6AED379E0E}"/>
              </a:ext>
            </a:extLst>
          </p:cNvPr>
          <p:cNvSpPr txBox="1"/>
          <p:nvPr/>
        </p:nvSpPr>
        <p:spPr>
          <a:xfrm>
            <a:off x="2520461" y="5705292"/>
            <a:ext cx="73773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pporting </a:t>
            </a:r>
            <a:r>
              <a:rPr lang="en-US" altLang="ja-JP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Figure 1. </a:t>
            </a:r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Ultrasonographic image showing</a:t>
            </a:r>
          </a:p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subcutaneous mesenteric varices (white arrow).  </a:t>
            </a:r>
          </a:p>
        </p:txBody>
      </p:sp>
      <p:sp>
        <p:nvSpPr>
          <p:cNvPr id="7" name="矢印: 下 6">
            <a:extLst>
              <a:ext uri="{FF2B5EF4-FFF2-40B4-BE49-F238E27FC236}">
                <a16:creationId xmlns:a16="http://schemas.microsoft.com/office/drawing/2014/main" id="{F20E44D3-79CB-1AF6-A20A-EA60B6E23676}"/>
              </a:ext>
            </a:extLst>
          </p:cNvPr>
          <p:cNvSpPr/>
          <p:nvPr/>
        </p:nvSpPr>
        <p:spPr>
          <a:xfrm rot="13542340">
            <a:off x="4214044" y="4705173"/>
            <a:ext cx="160232" cy="806969"/>
          </a:xfrm>
          <a:prstGeom prst="downArrow">
            <a:avLst>
              <a:gd name="adj1" fmla="val 70483"/>
              <a:gd name="adj2" fmla="val 50000"/>
            </a:avLst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87825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473cef40-5c85-4c4a-b41b-9378f7da5d40" xsi:nil="true"/>
    <lcf76f155ced4ddcb4097134ff3c332f xmlns="a2d3df0c-b642-49de-aebc-0bdfbd4fcb12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88DFAD2F25B8E48B7434BEA17FFE1EF" ma:contentTypeVersion="10" ma:contentTypeDescription="Create a new document." ma:contentTypeScope="" ma:versionID="91876025a5c4ab45c8686cbe266088b2">
  <xsd:schema xmlns:xsd="http://www.w3.org/2001/XMLSchema" xmlns:xs="http://www.w3.org/2001/XMLSchema" xmlns:p="http://schemas.microsoft.com/office/2006/metadata/properties" xmlns:ns2="a2d3df0c-b642-49de-aebc-0bdfbd4fcb12" xmlns:ns3="473cef40-5c85-4c4a-b41b-9378f7da5d40" targetNamespace="http://schemas.microsoft.com/office/2006/metadata/properties" ma:root="true" ma:fieldsID="067f483724e5b0d9a574cc19dabddd1f" ns2:_="" ns3:_="">
    <xsd:import namespace="a2d3df0c-b642-49de-aebc-0bdfbd4fcb12"/>
    <xsd:import namespace="473cef40-5c85-4c4a-b41b-9378f7da5d40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2d3df0c-b642-49de-aebc-0bdfbd4fcb12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lcf76f155ced4ddcb4097134ff3c332f" ma:index="16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3cef40-5c85-4c4a-b41b-9378f7da5d40" elementFormDefault="qualified">
    <xsd:import namespace="http://schemas.microsoft.com/office/2006/documentManagement/types"/>
    <xsd:import namespace="http://schemas.microsoft.com/office/infopath/2007/PartnerControls"/>
    <xsd:element name="TaxCatchAll" ma:index="17" nillable="true" ma:displayName="Taxonomy Catch All Column" ma:hidden="true" ma:list="{a30e90b5-2565-4993-a569-1b992df32115}" ma:internalName="TaxCatchAll" ma:showField="CatchAllData" ma:web="473cef40-5c85-4c4a-b41b-9378f7da5d40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B18D55E2-413B-4E25-8B6B-BCC3D2342325}">
  <ds:schemaRefs>
    <ds:schemaRef ds:uri="http://schemas.microsoft.com/office/2006/metadata/properties"/>
    <ds:schemaRef ds:uri="http://schemas.microsoft.com/office/infopath/2007/PartnerControls"/>
    <ds:schemaRef ds:uri="473cef40-5c85-4c4a-b41b-9378f7da5d40"/>
    <ds:schemaRef ds:uri="a2d3df0c-b642-49de-aebc-0bdfbd4fcb12"/>
  </ds:schemaRefs>
</ds:datastoreItem>
</file>

<file path=customXml/itemProps2.xml><?xml version="1.0" encoding="utf-8"?>
<ds:datastoreItem xmlns:ds="http://schemas.openxmlformats.org/officeDocument/2006/customXml" ds:itemID="{C18EBD1A-E5B4-4DBA-95F9-573569A1F21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2d3df0c-b642-49de-aebc-0bdfbd4fcb12"/>
    <ds:schemaRef ds:uri="473cef40-5c85-4c4a-b41b-9378f7da5d40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38626503-F22A-4448-B046-E36B1DEE13B3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80</TotalTime>
  <Words>14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彩夏 櫻井</dc:creator>
  <cp:lastModifiedBy>Arai Seiji</cp:lastModifiedBy>
  <cp:revision>45</cp:revision>
  <dcterms:created xsi:type="dcterms:W3CDTF">2023-02-23T11:46:52Z</dcterms:created>
  <dcterms:modified xsi:type="dcterms:W3CDTF">2023-08-23T07:29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88DFAD2F25B8E48B7434BEA17FFE1EF</vt:lpwstr>
  </property>
</Properties>
</file>